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801600" cy="9601200" type="A3"/>
  <p:notesSz cx="10234613" cy="14662150"/>
  <p:defaultTextStyle>
    <a:defPPr>
      <a:defRPr lang="fr-FR"/>
    </a:defPPr>
    <a:lvl1pPr marL="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2340" y="-72"/>
      </p:cViewPr>
      <p:guideLst>
        <p:guide orient="horz" pos="3024"/>
        <p:guide pos="40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960120" y="2982596"/>
            <a:ext cx="10881360" cy="205803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920240" y="5440680"/>
            <a:ext cx="8961120" cy="24536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1444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7820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9281160" y="384494"/>
            <a:ext cx="2880360" cy="819213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40080" y="384494"/>
            <a:ext cx="8427720" cy="819213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7100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03740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011238" y="6169661"/>
            <a:ext cx="10881360" cy="1906905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1011238" y="4069399"/>
            <a:ext cx="10881360" cy="2100262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3267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640080" y="2240281"/>
            <a:ext cx="5654040" cy="633634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507480" y="2240281"/>
            <a:ext cx="5654040" cy="633634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4079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40080" y="2149158"/>
            <a:ext cx="5656263" cy="895667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40080" y="3044825"/>
            <a:ext cx="5656263" cy="5531803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503036" y="2149158"/>
            <a:ext cx="5658485" cy="895667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503036" y="3044825"/>
            <a:ext cx="5658485" cy="5531803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9532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759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3934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40081" y="382270"/>
            <a:ext cx="4211638" cy="162687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005070" y="382271"/>
            <a:ext cx="7156450" cy="8194358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40081" y="2009141"/>
            <a:ext cx="4211638" cy="6567488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1584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509203" y="6720840"/>
            <a:ext cx="7680960" cy="793433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509203" y="857885"/>
            <a:ext cx="7680960" cy="576072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509203" y="7514273"/>
            <a:ext cx="7680960" cy="1126807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55587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640080" y="384493"/>
            <a:ext cx="11521440" cy="16002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40080" y="2240281"/>
            <a:ext cx="11521440" cy="6336348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640080" y="8898891"/>
            <a:ext cx="2987040" cy="511175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0A329-766B-4E40-8346-CF7254059525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373880" y="8898891"/>
            <a:ext cx="4053840" cy="511175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9174480" y="8898891"/>
            <a:ext cx="2987040" cy="511175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36E397-E4BF-46C9-85DF-4D352C362F5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0844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package" Target="../embeddings/Microsoft_Excel_Worksheet1.xls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Connecteur droit 7"/>
          <p:cNvCxnSpPr/>
          <p:nvPr/>
        </p:nvCxnSpPr>
        <p:spPr>
          <a:xfrm>
            <a:off x="568152" y="8022014"/>
            <a:ext cx="16561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9"/>
          <p:cNvCxnSpPr/>
          <p:nvPr/>
        </p:nvCxnSpPr>
        <p:spPr>
          <a:xfrm>
            <a:off x="2278428" y="8022014"/>
            <a:ext cx="15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>
            <a:off x="3880520" y="8022014"/>
            <a:ext cx="16561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5590796" y="8022014"/>
            <a:ext cx="15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7192888" y="8022014"/>
            <a:ext cx="18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ZoneTexte 8"/>
          <p:cNvSpPr txBox="1"/>
          <p:nvPr/>
        </p:nvSpPr>
        <p:spPr>
          <a:xfrm>
            <a:off x="1072208" y="8022014"/>
            <a:ext cx="6480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 smtClean="0"/>
              <a:t>LH1-LH2</a:t>
            </a:r>
            <a:endParaRPr lang="fr-FR" sz="1050" dirty="0"/>
          </a:p>
        </p:txBody>
      </p:sp>
      <p:sp>
        <p:nvSpPr>
          <p:cNvPr id="15" name="ZoneTexte 14"/>
          <p:cNvSpPr txBox="1"/>
          <p:nvPr/>
        </p:nvSpPr>
        <p:spPr>
          <a:xfrm>
            <a:off x="2728392" y="8022014"/>
            <a:ext cx="6480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/>
              <a:t>C</a:t>
            </a:r>
            <a:r>
              <a:rPr lang="fr-FR" sz="1050" dirty="0" smtClean="0"/>
              <a:t>1-LH2</a:t>
            </a:r>
            <a:endParaRPr lang="fr-FR" sz="1050" dirty="0"/>
          </a:p>
        </p:txBody>
      </p:sp>
      <p:sp>
        <p:nvSpPr>
          <p:cNvPr id="16" name="ZoneTexte 15"/>
          <p:cNvSpPr txBox="1"/>
          <p:nvPr/>
        </p:nvSpPr>
        <p:spPr>
          <a:xfrm>
            <a:off x="4384576" y="8022014"/>
            <a:ext cx="6480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 smtClean="0"/>
              <a:t>C1-C2</a:t>
            </a:r>
            <a:endParaRPr lang="fr-FR" sz="1050" dirty="0"/>
          </a:p>
        </p:txBody>
      </p:sp>
      <p:sp>
        <p:nvSpPr>
          <p:cNvPr id="17" name="ZoneTexte 16"/>
          <p:cNvSpPr txBox="1"/>
          <p:nvPr/>
        </p:nvSpPr>
        <p:spPr>
          <a:xfrm>
            <a:off x="6040760" y="8022014"/>
            <a:ext cx="6480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 smtClean="0"/>
              <a:t>C1-HG2</a:t>
            </a:r>
            <a:endParaRPr lang="fr-FR" sz="1050" dirty="0"/>
          </a:p>
        </p:txBody>
      </p:sp>
      <p:sp>
        <p:nvSpPr>
          <p:cNvPr id="18" name="ZoneTexte 17"/>
          <p:cNvSpPr txBox="1"/>
          <p:nvPr/>
        </p:nvSpPr>
        <p:spPr>
          <a:xfrm>
            <a:off x="7696944" y="8022014"/>
            <a:ext cx="7200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 smtClean="0"/>
              <a:t>HG1-HG2</a:t>
            </a:r>
            <a:endParaRPr lang="fr-FR" sz="1050" dirty="0"/>
          </a:p>
        </p:txBody>
      </p:sp>
      <p:sp>
        <p:nvSpPr>
          <p:cNvPr id="2" name="ZoneTexte 1"/>
          <p:cNvSpPr txBox="1"/>
          <p:nvPr/>
        </p:nvSpPr>
        <p:spPr>
          <a:xfrm>
            <a:off x="288032" y="1325270"/>
            <a:ext cx="1237746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itchFamily="34" charset="0"/>
                <a:cs typeface="Arial" pitchFamily="34" charset="0"/>
              </a:rPr>
              <a:t>Additional file 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4 </a:t>
            </a:r>
            <a:r>
              <a:rPr lang="en-GB" dirty="0">
                <a:latin typeface="Arial" pitchFamily="34" charset="0"/>
                <a:cs typeface="Arial" pitchFamily="34" charset="0"/>
              </a:rPr>
              <a:t>– Histogram showing the distribution of the most dominant OTUs (more than 5% total reads in at least one sample).</a:t>
            </a:r>
            <a:endParaRPr lang="fr-FR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" name="Obje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6638085"/>
              </p:ext>
            </p:extLst>
          </p:nvPr>
        </p:nvGraphicFramePr>
        <p:xfrm>
          <a:off x="0" y="2250000"/>
          <a:ext cx="13080907" cy="55622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5" name="Feuille de calcul" r:id="rId4" imgW="25155590" imgH="10696590" progId="Excel.Sheet.12">
                  <p:embed/>
                </p:oleObj>
              </mc:Choice>
              <mc:Fallback>
                <p:oleObj name="Feuille de calcul" r:id="rId4" imgW="25155590" imgH="1069659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2250000"/>
                        <a:ext cx="13080907" cy="55622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445485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31</Words>
  <Application>Microsoft Office PowerPoint</Application>
  <PresentationFormat>A3 (297 x 420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Thème Office</vt:lpstr>
      <vt:lpstr>Feuille de calcul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oel GATESOUPE</dc:creator>
  <cp:lastModifiedBy>Joel GATESOUPE</cp:lastModifiedBy>
  <cp:revision>6</cp:revision>
  <cp:lastPrinted>2016-09-26T09:25:28Z</cp:lastPrinted>
  <dcterms:created xsi:type="dcterms:W3CDTF">2016-09-26T07:10:01Z</dcterms:created>
  <dcterms:modified xsi:type="dcterms:W3CDTF">2016-10-28T13:45:05Z</dcterms:modified>
</cp:coreProperties>
</file>